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7" roundtripDataSignature="AMtx7mg+Q/vvpyxDzUytRh1TKcLDM6fgU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2010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folie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vertikaler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kaler Titel u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Inhalt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4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bschnitts-&#10;überschrift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Zwei Inhalte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gleich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ur Titel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eer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halt mit Überschrift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ld mit Überschrift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599429" y="8927465"/>
            <a:ext cx="5916000" cy="83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200" b="1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</a:t>
            </a:r>
            <a:r>
              <a:rPr lang="de-DE" sz="1200" b="1" dirty="0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S</a:t>
            </a:r>
            <a:r>
              <a:rPr lang="de-DE" sz="1200" b="1" dirty="0" smtClean="0">
                <a:solidFill>
                  <a:schemeClr val="dk1"/>
                </a:solidFill>
              </a:rPr>
              <a:t>2</a:t>
            </a:r>
            <a:r>
              <a:rPr lang="de-DE" sz="12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ffect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himera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etection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ltering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n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alysi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erformance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(A)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Yiel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alysi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oportion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</a:rPr>
              <a:t>retaine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ead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; (B) Average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cision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(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ecall-weighte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alysi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; (C)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uclidian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istance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etween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dicte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xpecte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value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 dirty="0"/>
          </a:p>
        </p:txBody>
      </p:sp>
      <p:pic>
        <p:nvPicPr>
          <p:cNvPr id="85" name="Google Shape;85;p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993288" y="183550"/>
            <a:ext cx="2871416" cy="862266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A4-Papier (210 x 297 mm)</PresentationFormat>
  <Paragraphs>1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ay Dr. Grégoire</dc:creator>
  <cp:lastModifiedBy>Denay Dr. Grégoire</cp:lastModifiedBy>
  <cp:revision>1</cp:revision>
  <dcterms:created xsi:type="dcterms:W3CDTF">2022-08-22T10:51:50Z</dcterms:created>
  <dcterms:modified xsi:type="dcterms:W3CDTF">2023-02-22T07:46:15Z</dcterms:modified>
</cp:coreProperties>
</file>